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sldIdLst>
    <p:sldId id="256" r:id="rId3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464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1.xml"/><Relationship Id="rId7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CA886-A286-499A-A20C-0C5AE8E2F9E4}" type="datetimeFigureOut">
              <a:rPr lang="de-DE" smtClean="0"/>
              <a:t>06.07.2014</a:t>
            </a:fld>
            <a:endParaRPr lang="de-DE" dirty="0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356E0-C0BC-4FD7-B464-5E9FCF897629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3763420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CA886-A286-499A-A20C-0C5AE8E2F9E4}" type="datetimeFigureOut">
              <a:rPr lang="de-DE" smtClean="0"/>
              <a:t>06.07.2014</a:t>
            </a:fld>
            <a:endParaRPr lang="de-DE" dirty="0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356E0-C0BC-4FD7-B464-5E9FCF897629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4175533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CA886-A286-499A-A20C-0C5AE8E2F9E4}" type="datetimeFigureOut">
              <a:rPr lang="de-DE" smtClean="0"/>
              <a:t>06.07.2014</a:t>
            </a:fld>
            <a:endParaRPr lang="de-DE" dirty="0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356E0-C0BC-4FD7-B464-5E9FCF897629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6154505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8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2267A5-1C44-44AD-99D3-1F59D3C2BED1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6/2014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B9167-D80E-4E38-B01A-4EA6D00D8740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12799938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2267A5-1C44-44AD-99D3-1F59D3C2BED1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6/2014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B9167-D80E-4E38-B01A-4EA6D00D8740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20371170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2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6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2267A5-1C44-44AD-99D3-1F59D3C2BED1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6/2014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B9167-D80E-4E38-B01A-4EA6D00D8740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2020790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3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3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2267A5-1C44-44AD-99D3-1F59D3C2BED1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6/2014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B9167-D80E-4E38-B01A-4EA6D00D8740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06525288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2267A5-1C44-44AD-99D3-1F59D3C2BED1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6/2014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B9167-D80E-4E38-B01A-4EA6D00D8740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3107346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2267A5-1C44-44AD-99D3-1F59D3C2BED1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6/2014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B9167-D80E-4E38-B01A-4EA6D00D8740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63441201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2267A5-1C44-44AD-99D3-1F59D3C2BED1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6/2014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B9167-D80E-4E38-B01A-4EA6D00D8740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09235918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1" y="273052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2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2267A5-1C44-44AD-99D3-1F59D3C2BED1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6/2014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B9167-D80E-4E38-B01A-4EA6D00D8740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323685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CA886-A286-499A-A20C-0C5AE8E2F9E4}" type="datetimeFigureOut">
              <a:rPr lang="de-DE" smtClean="0"/>
              <a:t>06.07.2014</a:t>
            </a:fld>
            <a:endParaRPr lang="de-DE" dirty="0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356E0-C0BC-4FD7-B464-5E9FCF897629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161582609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2267A5-1C44-44AD-99D3-1F59D3C2BED1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6/2014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B9167-D80E-4E38-B01A-4EA6D00D8740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72348021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2267A5-1C44-44AD-99D3-1F59D3C2BED1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6/2014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B9167-D80E-4E38-B01A-4EA6D00D8740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58142987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2267A5-1C44-44AD-99D3-1F59D3C2BED1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6/2014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B9167-D80E-4E38-B01A-4EA6D00D8740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16522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CA886-A286-499A-A20C-0C5AE8E2F9E4}" type="datetimeFigureOut">
              <a:rPr lang="de-DE" smtClean="0"/>
              <a:t>06.07.2014</a:t>
            </a:fld>
            <a:endParaRPr lang="de-DE" dirty="0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356E0-C0BC-4FD7-B464-5E9FCF897629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9227119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CA886-A286-499A-A20C-0C5AE8E2F9E4}" type="datetimeFigureOut">
              <a:rPr lang="de-DE" smtClean="0"/>
              <a:t>06.07.2014</a:t>
            </a:fld>
            <a:endParaRPr lang="de-DE" dirty="0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356E0-C0BC-4FD7-B464-5E9FCF897629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3658900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CA886-A286-499A-A20C-0C5AE8E2F9E4}" type="datetimeFigureOut">
              <a:rPr lang="de-DE" smtClean="0"/>
              <a:t>06.07.2014</a:t>
            </a:fld>
            <a:endParaRPr lang="de-DE" dirty="0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356E0-C0BC-4FD7-B464-5E9FCF897629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2081473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CA886-A286-499A-A20C-0C5AE8E2F9E4}" type="datetimeFigureOut">
              <a:rPr lang="de-DE" smtClean="0"/>
              <a:t>06.07.2014</a:t>
            </a:fld>
            <a:endParaRPr lang="de-DE" dirty="0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356E0-C0BC-4FD7-B464-5E9FCF897629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0895286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CA886-A286-499A-A20C-0C5AE8E2F9E4}" type="datetimeFigureOut">
              <a:rPr lang="de-DE" smtClean="0"/>
              <a:t>06.07.2014</a:t>
            </a:fld>
            <a:endParaRPr lang="de-DE" dirty="0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356E0-C0BC-4FD7-B464-5E9FCF897629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42623089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CA886-A286-499A-A20C-0C5AE8E2F9E4}" type="datetimeFigureOut">
              <a:rPr lang="de-DE" smtClean="0"/>
              <a:t>06.07.2014</a:t>
            </a:fld>
            <a:endParaRPr lang="de-DE" dirty="0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356E0-C0BC-4FD7-B464-5E9FCF897629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730293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 dirty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CA886-A286-499A-A20C-0C5AE8E2F9E4}" type="datetimeFigureOut">
              <a:rPr lang="de-DE" smtClean="0"/>
              <a:t>06.07.2014</a:t>
            </a:fld>
            <a:endParaRPr lang="de-DE" dirty="0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356E0-C0BC-4FD7-B464-5E9FCF897629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3860134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5CA886-A286-499A-A20C-0C5AE8E2F9E4}" type="datetimeFigureOut">
              <a:rPr lang="de-DE" smtClean="0"/>
              <a:t>06.07.2014</a:t>
            </a:fld>
            <a:endParaRPr lang="de-DE" dirty="0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 dirty="0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0356E0-C0BC-4FD7-B464-5E9FCF897629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1219037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3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3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2267A5-1C44-44AD-99D3-1F59D3C2BED1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6/2014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3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3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8B9167-D80E-4E38-B01A-4EA6D00D8740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618728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8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3" name="Gruppieren 52"/>
          <p:cNvGrpSpPr/>
          <p:nvPr/>
        </p:nvGrpSpPr>
        <p:grpSpPr>
          <a:xfrm>
            <a:off x="242902" y="271445"/>
            <a:ext cx="7995709" cy="5265894"/>
            <a:chOff x="242902" y="271445"/>
            <a:chExt cx="7995709" cy="5265894"/>
          </a:xfrm>
        </p:grpSpPr>
        <p:grpSp>
          <p:nvGrpSpPr>
            <p:cNvPr id="17" name="Gruppieren 16"/>
            <p:cNvGrpSpPr/>
            <p:nvPr/>
          </p:nvGrpSpPr>
          <p:grpSpPr>
            <a:xfrm>
              <a:off x="538176" y="548444"/>
              <a:ext cx="3259518" cy="2477051"/>
              <a:chOff x="899592" y="1167970"/>
              <a:chExt cx="2988001" cy="2261030"/>
            </a:xfrm>
          </p:grpSpPr>
          <p:pic>
            <p:nvPicPr>
              <p:cNvPr id="4" name="Grafik 3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99592" y="1167970"/>
                <a:ext cx="2988001" cy="2261030"/>
              </a:xfrm>
              <a:prstGeom prst="rect">
                <a:avLst/>
              </a:prstGeom>
            </p:spPr>
          </p:pic>
          <p:sp>
            <p:nvSpPr>
              <p:cNvPr id="5" name="Textfeld 4"/>
              <p:cNvSpPr txBox="1"/>
              <p:nvPr/>
            </p:nvSpPr>
            <p:spPr>
              <a:xfrm>
                <a:off x="2123728" y="2167680"/>
                <a:ext cx="36099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1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de-DE" sz="11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de-DE" sz="11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Textfeld 6"/>
              <p:cNvSpPr txBox="1"/>
              <p:nvPr/>
            </p:nvSpPr>
            <p:spPr>
              <a:xfrm>
                <a:off x="2915816" y="2298485"/>
                <a:ext cx="36099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1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de-DE" sz="11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8" name="Textfeld 7"/>
              <p:cNvSpPr txBox="1"/>
              <p:nvPr/>
            </p:nvSpPr>
            <p:spPr>
              <a:xfrm>
                <a:off x="2099880" y="1317488"/>
                <a:ext cx="36901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1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de-DE" sz="11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9" name="Textfeld 8"/>
              <p:cNvSpPr txBox="1"/>
              <p:nvPr/>
            </p:nvSpPr>
            <p:spPr>
              <a:xfrm>
                <a:off x="1593411" y="1167970"/>
                <a:ext cx="36901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1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de-DE" sz="11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</a:p>
            </p:txBody>
          </p:sp>
          <p:sp>
            <p:nvSpPr>
              <p:cNvPr id="10" name="Textfeld 9"/>
              <p:cNvSpPr txBox="1"/>
              <p:nvPr/>
            </p:nvSpPr>
            <p:spPr>
              <a:xfrm>
                <a:off x="2329055" y="2329758"/>
                <a:ext cx="36099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1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de-DE" sz="11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de-DE" sz="11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Textfeld 10"/>
              <p:cNvSpPr txBox="1"/>
              <p:nvPr/>
            </p:nvSpPr>
            <p:spPr>
              <a:xfrm>
                <a:off x="2690051" y="2425365"/>
                <a:ext cx="36099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1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de-DE" sz="11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12" name="Textfeld 11"/>
              <p:cNvSpPr txBox="1"/>
              <p:nvPr/>
            </p:nvSpPr>
            <p:spPr>
              <a:xfrm>
                <a:off x="1854334" y="1906070"/>
                <a:ext cx="36901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1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de-DE" sz="11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de-DE" sz="11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Textfeld 13"/>
              <p:cNvSpPr txBox="1"/>
              <p:nvPr/>
            </p:nvSpPr>
            <p:spPr>
              <a:xfrm>
                <a:off x="1650483" y="2167680"/>
                <a:ext cx="36901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1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de-DE" sz="11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endParaRPr lang="de-DE" sz="11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Textfeld 14"/>
              <p:cNvSpPr txBox="1"/>
              <p:nvPr/>
            </p:nvSpPr>
            <p:spPr>
              <a:xfrm>
                <a:off x="2356305" y="2780928"/>
                <a:ext cx="33374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1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´</a:t>
                </a:r>
                <a:endParaRPr lang="de-DE" sz="11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Textfeld 15"/>
              <p:cNvSpPr txBox="1"/>
              <p:nvPr/>
            </p:nvSpPr>
            <p:spPr>
              <a:xfrm>
                <a:off x="1294792" y="2463422"/>
                <a:ext cx="33374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1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´</a:t>
                </a:r>
                <a:endParaRPr lang="de-DE" sz="11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9" name="Textfeld 38"/>
            <p:cNvSpPr txBox="1"/>
            <p:nvPr/>
          </p:nvSpPr>
          <p:spPr>
            <a:xfrm>
              <a:off x="242902" y="271445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de-DE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2" name="Gruppieren 51"/>
            <p:cNvGrpSpPr/>
            <p:nvPr/>
          </p:nvGrpSpPr>
          <p:grpSpPr>
            <a:xfrm>
              <a:off x="3978398" y="271445"/>
              <a:ext cx="4260213" cy="3179111"/>
              <a:chOff x="242902" y="3368022"/>
              <a:chExt cx="4260213" cy="3179111"/>
            </a:xfrm>
          </p:grpSpPr>
          <p:grpSp>
            <p:nvGrpSpPr>
              <p:cNvPr id="37" name="Gruppieren 36"/>
              <p:cNvGrpSpPr/>
              <p:nvPr/>
            </p:nvGrpSpPr>
            <p:grpSpPr>
              <a:xfrm>
                <a:off x="972078" y="3645022"/>
                <a:ext cx="3531037" cy="2902111"/>
                <a:chOff x="972078" y="3645022"/>
                <a:chExt cx="3531037" cy="2902111"/>
              </a:xfrm>
            </p:grpSpPr>
            <p:pic>
              <p:nvPicPr>
                <p:cNvPr id="6" name="Grafik 5"/>
                <p:cNvPicPr>
                  <a:picLocks noChangeAspect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972078" y="3645022"/>
                  <a:ext cx="2843028" cy="2902111"/>
                </a:xfrm>
                <a:prstGeom prst="rect">
                  <a:avLst/>
                </a:prstGeom>
              </p:spPr>
            </p:pic>
            <p:sp>
              <p:nvSpPr>
                <p:cNvPr id="18" name="Textfeld 17"/>
                <p:cNvSpPr txBox="1"/>
                <p:nvPr/>
              </p:nvSpPr>
              <p:spPr>
                <a:xfrm>
                  <a:off x="2129962" y="4965272"/>
                  <a:ext cx="36099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l-GR" sz="110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de-DE" sz="110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  <a:endParaRPr lang="de-DE" sz="11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" name="Textfeld 18"/>
                <p:cNvSpPr txBox="1"/>
                <p:nvPr/>
              </p:nvSpPr>
              <p:spPr>
                <a:xfrm>
                  <a:off x="3011211" y="4800913"/>
                  <a:ext cx="36099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l-GR" sz="110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de-DE" sz="110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</a:p>
              </p:txBody>
            </p:sp>
            <p:sp>
              <p:nvSpPr>
                <p:cNvPr id="20" name="Textfeld 19"/>
                <p:cNvSpPr txBox="1"/>
                <p:nvPr/>
              </p:nvSpPr>
              <p:spPr>
                <a:xfrm>
                  <a:off x="2171799" y="4031486"/>
                  <a:ext cx="369012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l-GR" sz="110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de-DE" sz="110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</a:p>
              </p:txBody>
            </p:sp>
            <p:sp>
              <p:nvSpPr>
                <p:cNvPr id="21" name="Textfeld 20"/>
                <p:cNvSpPr txBox="1"/>
                <p:nvPr/>
              </p:nvSpPr>
              <p:spPr>
                <a:xfrm>
                  <a:off x="1581627" y="3789040"/>
                  <a:ext cx="369012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l-GR" sz="110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de-DE" sz="110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</a:t>
                  </a:r>
                </a:p>
              </p:txBody>
            </p:sp>
            <p:sp>
              <p:nvSpPr>
                <p:cNvPr id="22" name="Textfeld 21"/>
                <p:cNvSpPr txBox="1"/>
                <p:nvPr/>
              </p:nvSpPr>
              <p:spPr>
                <a:xfrm>
                  <a:off x="2310460" y="5109016"/>
                  <a:ext cx="36099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l-GR" sz="110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de-DE" sz="110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  <a:endParaRPr lang="de-DE" sz="11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" name="Textfeld 22"/>
                <p:cNvSpPr txBox="1"/>
                <p:nvPr/>
              </p:nvSpPr>
              <p:spPr>
                <a:xfrm>
                  <a:off x="2665817" y="5105900"/>
                  <a:ext cx="36099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l-GR" sz="110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de-DE" sz="110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</a:p>
              </p:txBody>
            </p:sp>
            <p:sp>
              <p:nvSpPr>
                <p:cNvPr id="24" name="Textfeld 23"/>
                <p:cNvSpPr txBox="1"/>
                <p:nvPr/>
              </p:nvSpPr>
              <p:spPr>
                <a:xfrm>
                  <a:off x="1893280" y="4653136"/>
                  <a:ext cx="369012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l-GR" sz="110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de-DE" sz="110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  <a:endParaRPr lang="de-DE" sz="11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" name="Textfeld 24"/>
                <p:cNvSpPr txBox="1"/>
                <p:nvPr/>
              </p:nvSpPr>
              <p:spPr>
                <a:xfrm>
                  <a:off x="1650483" y="4771029"/>
                  <a:ext cx="369012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l-GR" sz="110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de-DE" sz="110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</a:t>
                  </a:r>
                  <a:endParaRPr lang="de-DE" sz="11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" name="Textfeld 25"/>
                <p:cNvSpPr txBox="1"/>
                <p:nvPr/>
              </p:nvSpPr>
              <p:spPr>
                <a:xfrm>
                  <a:off x="1789982" y="6093296"/>
                  <a:ext cx="33374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110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N´</a:t>
                  </a:r>
                  <a:endParaRPr lang="de-DE" sz="11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" name="Textfeld 26"/>
                <p:cNvSpPr txBox="1"/>
                <p:nvPr/>
              </p:nvSpPr>
              <p:spPr>
                <a:xfrm>
                  <a:off x="1426538" y="5805264"/>
                  <a:ext cx="33374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110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´</a:t>
                  </a:r>
                  <a:endParaRPr lang="de-DE" sz="11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" name="Runde Klammer rechts 27"/>
                <p:cNvSpPr/>
                <p:nvPr/>
              </p:nvSpPr>
              <p:spPr>
                <a:xfrm>
                  <a:off x="3725500" y="4509120"/>
                  <a:ext cx="89605" cy="861506"/>
                </a:xfrm>
                <a:prstGeom prst="rightBracket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de-DE" dirty="0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29" name="Textfeld 28"/>
                <p:cNvSpPr txBox="1"/>
                <p:nvPr/>
              </p:nvSpPr>
              <p:spPr>
                <a:xfrm>
                  <a:off x="3815106" y="4809068"/>
                  <a:ext cx="688009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110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BB-loop</a:t>
                  </a:r>
                  <a:endParaRPr lang="de-DE" sz="11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40" name="Textfeld 39"/>
              <p:cNvSpPr txBox="1"/>
              <p:nvPr/>
            </p:nvSpPr>
            <p:spPr>
              <a:xfrm>
                <a:off x="242902" y="3368022"/>
                <a:ext cx="29527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b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</p:grpSp>
        <p:grpSp>
          <p:nvGrpSpPr>
            <p:cNvPr id="58" name="Gruppieren 57"/>
            <p:cNvGrpSpPr/>
            <p:nvPr/>
          </p:nvGrpSpPr>
          <p:grpSpPr>
            <a:xfrm>
              <a:off x="242902" y="3698591"/>
              <a:ext cx="2590986" cy="1838748"/>
              <a:chOff x="648271" y="3481785"/>
              <a:chExt cx="2590986" cy="1838748"/>
            </a:xfrm>
          </p:grpSpPr>
          <p:grpSp>
            <p:nvGrpSpPr>
              <p:cNvPr id="38" name="Gruppieren 37"/>
              <p:cNvGrpSpPr/>
              <p:nvPr/>
            </p:nvGrpSpPr>
            <p:grpSpPr>
              <a:xfrm>
                <a:off x="943545" y="3774695"/>
                <a:ext cx="2295712" cy="1545838"/>
                <a:chOff x="4788025" y="3933054"/>
                <a:chExt cx="3468022" cy="2421852"/>
              </a:xfrm>
            </p:grpSpPr>
            <p:pic>
              <p:nvPicPr>
                <p:cNvPr id="30" name="Grafik 29"/>
                <p:cNvPicPr>
                  <a:picLocks noChangeAspect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788025" y="3933054"/>
                  <a:ext cx="2080143" cy="2326045"/>
                </a:xfrm>
                <a:prstGeom prst="rect">
                  <a:avLst/>
                </a:prstGeom>
              </p:spPr>
            </p:pic>
            <p:sp>
              <p:nvSpPr>
                <p:cNvPr id="31" name="Textfeld 30"/>
                <p:cNvSpPr txBox="1"/>
                <p:nvPr/>
              </p:nvSpPr>
              <p:spPr>
                <a:xfrm>
                  <a:off x="5436675" y="5936069"/>
                  <a:ext cx="782841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1100" dirty="0">
                      <a:solidFill>
                        <a:srgbClr val="CC00CC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Pro 48</a:t>
                  </a:r>
                  <a:endParaRPr lang="en-US" sz="1100" dirty="0">
                    <a:solidFill>
                      <a:srgbClr val="CC00CC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" name="Textfeld 31"/>
                <p:cNvSpPr txBox="1"/>
                <p:nvPr/>
              </p:nvSpPr>
              <p:spPr>
                <a:xfrm>
                  <a:off x="6753892" y="4694751"/>
                  <a:ext cx="778360" cy="33620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1100" dirty="0">
                      <a:solidFill>
                        <a:srgbClr val="CC00CC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Gly 49</a:t>
                  </a:r>
                  <a:endParaRPr lang="en-US" sz="1100" dirty="0">
                    <a:solidFill>
                      <a:srgbClr val="CC00CC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" name="Textfeld 32"/>
                <p:cNvSpPr txBox="1"/>
                <p:nvPr/>
              </p:nvSpPr>
              <p:spPr>
                <a:xfrm>
                  <a:off x="6485321" y="4231882"/>
                  <a:ext cx="733178" cy="26160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1100" dirty="0">
                      <a:solidFill>
                        <a:srgbClr val="00B05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Gly 676</a:t>
                  </a:r>
                  <a:endParaRPr lang="en-US" sz="1100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" name="Textfeld 33"/>
                <p:cNvSpPr txBox="1"/>
                <p:nvPr/>
              </p:nvSpPr>
              <p:spPr>
                <a:xfrm>
                  <a:off x="5937339" y="6018699"/>
                  <a:ext cx="914571" cy="33620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1100" dirty="0">
                      <a:solidFill>
                        <a:srgbClr val="00B05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Pro 675</a:t>
                  </a:r>
                  <a:endParaRPr lang="en-US" sz="1100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" name="Runde Klammer rechts 34"/>
                <p:cNvSpPr/>
                <p:nvPr/>
              </p:nvSpPr>
              <p:spPr>
                <a:xfrm>
                  <a:off x="7389227" y="3933054"/>
                  <a:ext cx="58639" cy="2326045"/>
                </a:xfrm>
                <a:prstGeom prst="rightBracket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 sz="11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" name="Textfeld 35"/>
                <p:cNvSpPr txBox="1"/>
                <p:nvPr/>
              </p:nvSpPr>
              <p:spPr>
                <a:xfrm>
                  <a:off x="7447866" y="4965272"/>
                  <a:ext cx="808181" cy="3362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110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BB-loop</a:t>
                  </a:r>
                  <a:endParaRPr lang="en-US" sz="11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41" name="Textfeld 40"/>
              <p:cNvSpPr txBox="1"/>
              <p:nvPr/>
            </p:nvSpPr>
            <p:spPr>
              <a:xfrm>
                <a:off x="648271" y="3481785"/>
                <a:ext cx="29527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b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</p:grpSp>
        <p:grpSp>
          <p:nvGrpSpPr>
            <p:cNvPr id="57" name="Gruppieren 56"/>
            <p:cNvGrpSpPr/>
            <p:nvPr/>
          </p:nvGrpSpPr>
          <p:grpSpPr>
            <a:xfrm>
              <a:off x="5628776" y="3699164"/>
              <a:ext cx="1944642" cy="1448412"/>
              <a:chOff x="7876708" y="2117747"/>
              <a:chExt cx="1944642" cy="1448412"/>
            </a:xfrm>
          </p:grpSpPr>
          <p:grpSp>
            <p:nvGrpSpPr>
              <p:cNvPr id="49" name="Gruppieren 48"/>
              <p:cNvGrpSpPr/>
              <p:nvPr/>
            </p:nvGrpSpPr>
            <p:grpSpPr>
              <a:xfrm>
                <a:off x="8171982" y="2315506"/>
                <a:ext cx="1649368" cy="1250653"/>
                <a:chOff x="4336826" y="2405970"/>
                <a:chExt cx="1649368" cy="1250653"/>
              </a:xfrm>
            </p:grpSpPr>
            <p:pic>
              <p:nvPicPr>
                <p:cNvPr id="2" name="Grafik 1"/>
                <p:cNvPicPr>
                  <a:picLocks noChangeAspect="1"/>
                </p:cNvPicPr>
                <p:nvPr/>
              </p:nvPicPr>
              <p:blipFill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597259" y="2405970"/>
                  <a:ext cx="1388935" cy="1239050"/>
                </a:xfrm>
                <a:prstGeom prst="rect">
                  <a:avLst/>
                </a:prstGeom>
              </p:spPr>
            </p:pic>
            <p:sp>
              <p:nvSpPr>
                <p:cNvPr id="3" name="Textfeld 2"/>
                <p:cNvSpPr txBox="1"/>
                <p:nvPr/>
              </p:nvSpPr>
              <p:spPr>
                <a:xfrm>
                  <a:off x="5015001" y="2599687"/>
                  <a:ext cx="599844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1100" dirty="0">
                      <a:solidFill>
                        <a:srgbClr val="CC00CC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Gln 76</a:t>
                  </a:r>
                  <a:endParaRPr lang="de-DE" sz="1100" dirty="0">
                    <a:solidFill>
                      <a:srgbClr val="CC00CC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2" name="Textfeld 41"/>
                <p:cNvSpPr txBox="1"/>
                <p:nvPr/>
              </p:nvSpPr>
              <p:spPr>
                <a:xfrm>
                  <a:off x="4336826" y="2832101"/>
                  <a:ext cx="599844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1100" dirty="0">
                      <a:solidFill>
                        <a:srgbClr val="00206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Lys 76</a:t>
                  </a:r>
                  <a:endParaRPr lang="de-DE" sz="1100" dirty="0">
                    <a:solidFill>
                      <a:srgbClr val="00206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6" name="Textfeld 45"/>
                <p:cNvSpPr txBox="1"/>
                <p:nvPr/>
              </p:nvSpPr>
              <p:spPr>
                <a:xfrm>
                  <a:off x="4896903" y="3025495"/>
                  <a:ext cx="369012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l-GR" sz="110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de-DE" sz="110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  <a:endParaRPr lang="de-DE" sz="11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7" name="Textfeld 46"/>
                <p:cNvSpPr txBox="1"/>
                <p:nvPr/>
              </p:nvSpPr>
              <p:spPr>
                <a:xfrm>
                  <a:off x="5606830" y="3395013"/>
                  <a:ext cx="36099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l-GR" sz="110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de-DE" sz="1100" dirty="0">
                      <a:solidFill>
                        <a:prstClr val="black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  <a:endParaRPr lang="de-DE" sz="11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51" name="Textfeld 50"/>
              <p:cNvSpPr txBox="1"/>
              <p:nvPr/>
            </p:nvSpPr>
            <p:spPr>
              <a:xfrm>
                <a:off x="7876708" y="2117747"/>
                <a:ext cx="28725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b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</a:t>
                </a:r>
              </a:p>
            </p:txBody>
          </p:sp>
        </p:grpSp>
        <p:grpSp>
          <p:nvGrpSpPr>
            <p:cNvPr id="13" name="Gruppieren 12"/>
            <p:cNvGrpSpPr/>
            <p:nvPr/>
          </p:nvGrpSpPr>
          <p:grpSpPr>
            <a:xfrm>
              <a:off x="3186907" y="3698591"/>
              <a:ext cx="2065584" cy="1616980"/>
              <a:chOff x="4228321" y="271445"/>
              <a:chExt cx="2065584" cy="1616980"/>
            </a:xfrm>
          </p:grpSpPr>
          <p:grpSp>
            <p:nvGrpSpPr>
              <p:cNvPr id="48" name="Gruppieren 47"/>
              <p:cNvGrpSpPr/>
              <p:nvPr/>
            </p:nvGrpSpPr>
            <p:grpSpPr>
              <a:xfrm>
                <a:off x="4523595" y="548444"/>
                <a:ext cx="1770310" cy="1339981"/>
                <a:chOff x="4215884" y="1102626"/>
                <a:chExt cx="1770310" cy="1339981"/>
              </a:xfrm>
            </p:grpSpPr>
            <p:pic>
              <p:nvPicPr>
                <p:cNvPr id="43" name="Grafik 42"/>
                <p:cNvPicPr>
                  <a:picLocks noChangeAspect="1"/>
                </p:cNvPicPr>
                <p:nvPr/>
              </p:nvPicPr>
              <p:blipFill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572694" y="1102626"/>
                  <a:ext cx="1413500" cy="1339981"/>
                </a:xfrm>
                <a:prstGeom prst="rect">
                  <a:avLst/>
                </a:prstGeom>
              </p:spPr>
            </p:pic>
            <p:sp>
              <p:nvSpPr>
                <p:cNvPr id="44" name="Textfeld 43"/>
                <p:cNvSpPr txBox="1"/>
                <p:nvPr/>
              </p:nvSpPr>
              <p:spPr>
                <a:xfrm>
                  <a:off x="4344841" y="1288796"/>
                  <a:ext cx="591829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1100" dirty="0">
                      <a:solidFill>
                        <a:srgbClr val="1F497D">
                          <a:lumMod val="75000"/>
                        </a:srgb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Thr 41</a:t>
                  </a:r>
                  <a:endParaRPr lang="de-DE" sz="1100" dirty="0">
                    <a:solidFill>
                      <a:srgbClr val="1F497D">
                        <a:lumMod val="75000"/>
                      </a:srgbClr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5" name="Textfeld 44"/>
                <p:cNvSpPr txBox="1"/>
                <p:nvPr/>
              </p:nvSpPr>
              <p:spPr>
                <a:xfrm>
                  <a:off x="4215884" y="1443738"/>
                  <a:ext cx="585417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1100" dirty="0">
                      <a:solidFill>
                        <a:srgbClr val="CC00CC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la 41</a:t>
                  </a:r>
                  <a:endParaRPr lang="de-DE" sz="1100" dirty="0">
                    <a:solidFill>
                      <a:srgbClr val="CC00CC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50" name="Textfeld 49"/>
              <p:cNvSpPr txBox="1"/>
              <p:nvPr/>
            </p:nvSpPr>
            <p:spPr>
              <a:xfrm>
                <a:off x="4228321" y="271445"/>
                <a:ext cx="29527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b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</a:p>
            </p:txBody>
          </p:sp>
          <p:sp>
            <p:nvSpPr>
              <p:cNvPr id="54" name="Textfeld 53"/>
              <p:cNvSpPr txBox="1"/>
              <p:nvPr/>
            </p:nvSpPr>
            <p:spPr>
              <a:xfrm>
                <a:off x="5272186" y="894404"/>
                <a:ext cx="36099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1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de-DE" sz="11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55" name="Textfeld 54"/>
              <p:cNvSpPr txBox="1"/>
              <p:nvPr/>
            </p:nvSpPr>
            <p:spPr>
              <a:xfrm>
                <a:off x="4784028" y="1525360"/>
                <a:ext cx="36099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1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βB</a:t>
                </a:r>
                <a:endParaRPr lang="de-DE" sz="11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9" name="Textfeld 58"/>
            <p:cNvSpPr txBox="1"/>
            <p:nvPr/>
          </p:nvSpPr>
          <p:spPr>
            <a:xfrm>
              <a:off x="790327" y="4292565"/>
              <a:ext cx="36099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1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de-DE" sz="11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3598269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1_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2</Words>
  <Application>Microsoft Office PowerPoint</Application>
  <PresentationFormat>Bildschirmpräsentation (4:3)</PresentationFormat>
  <Paragraphs>40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2</vt:i4>
      </vt:variant>
      <vt:variant>
        <vt:lpstr>Folientitel</vt:lpstr>
      </vt:variant>
      <vt:variant>
        <vt:i4>1</vt:i4>
      </vt:variant>
    </vt:vector>
  </HeadingPairs>
  <TitlesOfParts>
    <vt:vector size="3" baseType="lpstr">
      <vt:lpstr>Larissa</vt:lpstr>
      <vt:lpstr>1_Larissa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Thomas Krämer</dc:creator>
  <cp:lastModifiedBy>Thomas Krämer</cp:lastModifiedBy>
  <cp:revision>1</cp:revision>
  <dcterms:created xsi:type="dcterms:W3CDTF">2014-07-06T17:25:51Z</dcterms:created>
  <dcterms:modified xsi:type="dcterms:W3CDTF">2014-07-06T17:26:47Z</dcterms:modified>
</cp:coreProperties>
</file>